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64" r:id="rId3"/>
    <p:sldId id="261" r:id="rId4"/>
    <p:sldId id="262" r:id="rId5"/>
    <p:sldId id="26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00" autoAdjust="0"/>
    <p:restoredTop sz="76506" autoAdjust="0"/>
  </p:normalViewPr>
  <p:slideViewPr>
    <p:cSldViewPr snapToGrid="0">
      <p:cViewPr varScale="1">
        <p:scale>
          <a:sx n="55" d="100"/>
          <a:sy n="55" d="100"/>
        </p:scale>
        <p:origin x="1512" y="2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9327D6-A170-4F41-857F-8DE97D9A464E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392BBB-2114-4A79-AC85-91DAE99B67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4358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1C4DF1-7D46-4613-9EA6-0695271EA0A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2954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9BB6508-C457-B6E4-C938-54AD3339570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389BA23-CAEC-D7B7-77F4-8B18345AF62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B0955026-862D-9011-9632-3E068AC5613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CC88981-45AD-96EF-7DEB-75122EBAEA5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1C4DF1-7D46-4613-9EA6-0695271EA0A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54022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1C4DF1-7D46-4613-9EA6-0695271EA0A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4900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4A695C-16D0-DC5C-0026-AA7033BF93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0CBBFF-E029-60B4-37F5-DFB7604AA4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E95B0F-13B6-E69E-7386-1C3ABD37A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0C1DC6-5C60-22F5-FF5F-0675D367E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1EE727-D02F-1C87-DA47-0A3EDD5B3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581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B5FD1-0F05-F902-F64D-D1EA0E17E5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599ACB-6DA9-C04C-B823-5980FD050E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4E5B03-4979-6B5F-7766-6262A9749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6BAA26-3FC8-A8EC-FAAB-51C2F443C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A6CD55-7E48-B8D0-2FA3-F2F5E6F98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209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E36E36-622D-3003-5B9E-D627BAFEA9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4830BC-5FF3-7D8F-E6F2-1A62FEEDDF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0C5671-3B77-BA2E-E34E-12D7D1F84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D930E0-730C-661C-47D6-8EDC657DC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CFD7E4-D488-1C11-A600-C69404028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273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444D98-1741-F978-612E-FA25F36E1C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DF6F72-3785-7BAE-5E1C-9109752597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F32110-4BEB-5857-C80F-B77E62019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9A0E6C-B086-11CB-B008-D9F9AB225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052E81-7DAC-A7B5-507A-3996A652D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1424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987E34-75C2-54DA-04D9-97F10697C6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CA632B-8F84-75B9-2550-7B7F448678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BC5CFC-AE98-F1C4-D90F-9F982FC9F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E223C-2E73-5017-E8A1-2766A8FC4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E9B704-6B17-1DAE-763A-443FFE2CA5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245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FB32FE-4F95-89DF-B0A0-A01DB550A5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BC1D91-EB63-435B-FE1E-5458C8ED1A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C45D24-6C52-64D8-2912-62DC045CEE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3DBC73-C4E0-BFC1-E9C0-7302F0BEA8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1FCAE0-F41D-9C93-F437-22E5A2B59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56F6CC-5203-D988-BEB9-F73A7211B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520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867D07-139E-73A1-E854-118354661C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789D60-BD92-E35B-41ED-9545D12BF4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BA0DC1-7103-672B-815E-03AA56C86B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1BB59F6-9FCD-A9E1-DC1B-42F66FA677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106ABCA-D43D-FF90-9363-C40CC8C0E8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455C97-9012-16E8-FA2F-C414D05F98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EE4EACC-BEB4-4105-54F9-BB580FB1A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EF916E2-65C9-97E7-1B55-65892DFDA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932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64B608-EB76-555D-59E6-C11D77F30B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4358894-8E50-97D2-49D0-C1177B4F9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B9FF87-8BD8-CC47-21F6-F435DD84F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33405-F7BE-6523-FF6E-90262393D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527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B1050F7-23FF-E5E9-6943-C7E6F5135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36D6B4-E6A3-F102-53D7-3BAD5EE53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09FEE0C-7D1D-A277-BD81-F3579A1A3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378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4ED77A-6B8C-82B0-AA25-11CE20ACD4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A9D4EB-96DF-BA1B-BC23-F12373E4E1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A90A38-85CB-7C63-AE17-EC36EFEAC1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DAE717-8636-5D03-9773-89F83B4CD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F11548-7AC4-9395-609C-39C1BAFA5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41D06D-7C8F-1CA6-A308-F184D5172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941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528E41-0C9D-BA47-F0B2-F781D05DE4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3AA3BC2-84EA-BF1D-8D72-064F4008B3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52E599-B5CB-4BBC-7010-76CC0CD7D9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8719B1-11E7-CA2B-F73A-5263005F8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404466-7408-A8A7-7116-B3CC83F08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38F269-3FD4-62F3-2500-1A32C8FEC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189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276B20-8B38-B272-57D0-1198FCF75C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5E78ED-2942-E544-9357-A1D417EA89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4A47F6-B08D-ED4D-F685-9964261152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446F77-1206-4642-8163-FB935BFA5EE6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EEA7D1-2F45-F740-FC1F-BFEB73A9AC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9AA619-64BF-07A6-03D7-F5EBB4EFDC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3AF92A-A68D-448B-8D95-BAE4F46AF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701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pn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jpeg"/><Relationship Id="rId4" Type="http://schemas.openxmlformats.org/officeDocument/2006/relationships/image" Target="../media/image2.png"/><Relationship Id="rId9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png"/><Relationship Id="rId7" Type="http://schemas.openxmlformats.org/officeDocument/2006/relationships/image" Target="../media/image14.jp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g"/><Relationship Id="rId3" Type="http://schemas.openxmlformats.org/officeDocument/2006/relationships/image" Target="../media/image16.png"/><Relationship Id="rId7" Type="http://schemas.openxmlformats.org/officeDocument/2006/relationships/image" Target="../media/image20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10" Type="http://schemas.openxmlformats.org/officeDocument/2006/relationships/image" Target="../media/image23.jpeg"/><Relationship Id="rId4" Type="http://schemas.openxmlformats.org/officeDocument/2006/relationships/image" Target="../media/image17.png"/><Relationship Id="rId9" Type="http://schemas.openxmlformats.org/officeDocument/2006/relationships/image" Target="../media/image22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eg"/><Relationship Id="rId3" Type="http://schemas.openxmlformats.org/officeDocument/2006/relationships/image" Target="../media/image25.png"/><Relationship Id="rId7" Type="http://schemas.openxmlformats.org/officeDocument/2006/relationships/image" Target="../media/image29.jp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jpg"/><Relationship Id="rId5" Type="http://schemas.openxmlformats.org/officeDocument/2006/relationships/image" Target="../media/image27.png"/><Relationship Id="rId4" Type="http://schemas.openxmlformats.org/officeDocument/2006/relationships/image" Target="../media/image26.png"/><Relationship Id="rId9" Type="http://schemas.openxmlformats.org/officeDocument/2006/relationships/image" Target="../media/image3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F7849943-A50E-0512-85A8-E319E845ACC0}"/>
              </a:ext>
            </a:extLst>
          </p:cNvPr>
          <p:cNvSpPr txBox="1"/>
          <p:nvPr/>
        </p:nvSpPr>
        <p:spPr>
          <a:xfrm>
            <a:off x="0" y="4710021"/>
            <a:ext cx="1779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F9DD88B-6C36-EC7D-EDD4-F2BA4A472031}"/>
              </a:ext>
            </a:extLst>
          </p:cNvPr>
          <p:cNvSpPr txBox="1"/>
          <p:nvPr/>
        </p:nvSpPr>
        <p:spPr>
          <a:xfrm>
            <a:off x="5483268" y="1529834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ampl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BB05AC3-D6F2-D8A3-B0AB-33C63A49A089}"/>
              </a:ext>
            </a:extLst>
          </p:cNvPr>
          <p:cNvSpPr txBox="1"/>
          <p:nvPr/>
        </p:nvSpPr>
        <p:spPr>
          <a:xfrm>
            <a:off x="4257804" y="1529834"/>
            <a:ext cx="834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for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E91BCA8-48D8-94D6-1009-6468BA885F30}"/>
              </a:ext>
            </a:extLst>
          </p:cNvPr>
          <p:cNvSpPr txBox="1"/>
          <p:nvPr/>
        </p:nvSpPr>
        <p:spPr>
          <a:xfrm>
            <a:off x="7099993" y="1524000"/>
            <a:ext cx="664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fte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0148338-FAAB-1224-437D-A01E4EDC2101}"/>
              </a:ext>
            </a:extLst>
          </p:cNvPr>
          <p:cNvSpPr txBox="1"/>
          <p:nvPr/>
        </p:nvSpPr>
        <p:spPr>
          <a:xfrm>
            <a:off x="50104" y="6435204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  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3654609-4224-EBC8-FC0F-B9B4A15DE3F6}"/>
              </a:ext>
            </a:extLst>
          </p:cNvPr>
          <p:cNvSpPr txBox="1"/>
          <p:nvPr/>
        </p:nvSpPr>
        <p:spPr>
          <a:xfrm>
            <a:off x="8915398" y="4697170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45AF784-9968-3908-2FB4-D8B369470A91}"/>
              </a:ext>
            </a:extLst>
          </p:cNvPr>
          <p:cNvSpPr txBox="1"/>
          <p:nvPr/>
        </p:nvSpPr>
        <p:spPr>
          <a:xfrm>
            <a:off x="8927402" y="6422353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 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DFA0410-50CC-471A-0A73-B09E64BF81F6}"/>
              </a:ext>
            </a:extLst>
          </p:cNvPr>
          <p:cNvSpPr txBox="1"/>
          <p:nvPr/>
        </p:nvSpPr>
        <p:spPr>
          <a:xfrm>
            <a:off x="8999984" y="4716445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A791492-5F30-AB38-5D4B-54EDF3BB6BD4}"/>
              </a:ext>
            </a:extLst>
          </p:cNvPr>
          <p:cNvSpPr txBox="1"/>
          <p:nvPr/>
        </p:nvSpPr>
        <p:spPr>
          <a:xfrm>
            <a:off x="5220251" y="4643169"/>
            <a:ext cx="354584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3 </a:t>
            </a: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r>
              <a:rPr lang="en-US" b="1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B1A7D4C-E24C-39A0-2397-BA6A6E1E3999}"/>
              </a:ext>
            </a:extLst>
          </p:cNvPr>
          <p:cNvSpPr txBox="1"/>
          <p:nvPr/>
        </p:nvSpPr>
        <p:spPr>
          <a:xfrm>
            <a:off x="7953926" y="4643169"/>
            <a:ext cx="354584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3 </a:t>
            </a: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r>
              <a:rPr lang="en-US" b="1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C26E6AF3-4735-D02B-ED2E-32659C37BD7F}"/>
              </a:ext>
            </a:extLst>
          </p:cNvPr>
          <p:cNvSpPr/>
          <p:nvPr/>
        </p:nvSpPr>
        <p:spPr>
          <a:xfrm>
            <a:off x="0" y="0"/>
            <a:ext cx="3314700" cy="3315942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olor Image</a:t>
            </a:r>
          </a:p>
          <a:p>
            <a:pPr algn="ctr"/>
            <a:r>
              <a:rPr lang="en-US" dirty="0"/>
              <a:t>(Before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A1BB29E-7812-CCBA-BC6C-DCC071B4240D}"/>
              </a:ext>
            </a:extLst>
          </p:cNvPr>
          <p:cNvSpPr/>
          <p:nvPr/>
        </p:nvSpPr>
        <p:spPr>
          <a:xfrm>
            <a:off x="8915398" y="0"/>
            <a:ext cx="3314700" cy="3315942"/>
          </a:xfrm>
          <a:prstGeom prst="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olor Image</a:t>
            </a:r>
          </a:p>
          <a:p>
            <a:pPr algn="ctr"/>
            <a:r>
              <a:rPr lang="en-US" dirty="0"/>
              <a:t>(after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76E7C07-D312-29E8-B0F2-FCF7793F3C81}"/>
              </a:ext>
            </a:extLst>
          </p:cNvPr>
          <p:cNvSpPr/>
          <p:nvPr/>
        </p:nvSpPr>
        <p:spPr>
          <a:xfrm>
            <a:off x="19985" y="3575944"/>
            <a:ext cx="3314700" cy="1153024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Reflectance Image</a:t>
            </a:r>
          </a:p>
          <a:p>
            <a:pPr algn="ctr"/>
            <a:r>
              <a:rPr lang="en-US" dirty="0"/>
              <a:t>(VIS-NIR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B7EB0AF-12E0-8909-00BC-902EE695138A}"/>
              </a:ext>
            </a:extLst>
          </p:cNvPr>
          <p:cNvSpPr/>
          <p:nvPr/>
        </p:nvSpPr>
        <p:spPr>
          <a:xfrm>
            <a:off x="0" y="5224462"/>
            <a:ext cx="3314700" cy="1153024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Fluorescence Image</a:t>
            </a:r>
          </a:p>
          <a:p>
            <a:pPr algn="ctr"/>
            <a:endParaRPr lang="en-US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70FCA97F-4FCB-4628-333C-D41712072575}"/>
              </a:ext>
            </a:extLst>
          </p:cNvPr>
          <p:cNvSpPr/>
          <p:nvPr/>
        </p:nvSpPr>
        <p:spPr>
          <a:xfrm>
            <a:off x="3490009" y="3421380"/>
            <a:ext cx="2369792" cy="343661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Reflectance Image</a:t>
            </a:r>
          </a:p>
          <a:p>
            <a:pPr algn="ctr"/>
            <a:r>
              <a:rPr lang="en-US" dirty="0"/>
              <a:t>(SWIR)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B855226B-0B88-EE7B-644D-7CFAE3E48CF2}"/>
              </a:ext>
            </a:extLst>
          </p:cNvPr>
          <p:cNvSpPr/>
          <p:nvPr/>
        </p:nvSpPr>
        <p:spPr>
          <a:xfrm>
            <a:off x="6241942" y="3421380"/>
            <a:ext cx="2369792" cy="3436619"/>
          </a:xfrm>
          <a:prstGeom prst="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Reflectance Image</a:t>
            </a:r>
          </a:p>
          <a:p>
            <a:pPr algn="ctr"/>
            <a:r>
              <a:rPr lang="en-US" dirty="0"/>
              <a:t>(SWIR)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72F7B36-E82E-B0B8-D824-5E03BB0E4D01}"/>
              </a:ext>
            </a:extLst>
          </p:cNvPr>
          <p:cNvSpPr/>
          <p:nvPr/>
        </p:nvSpPr>
        <p:spPr>
          <a:xfrm>
            <a:off x="8857315" y="3575944"/>
            <a:ext cx="3314700" cy="1153024"/>
          </a:xfrm>
          <a:prstGeom prst="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Reflectance Image</a:t>
            </a:r>
          </a:p>
          <a:p>
            <a:pPr algn="ctr"/>
            <a:r>
              <a:rPr lang="en-US" dirty="0"/>
              <a:t>(VIS-NIR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9921C7B2-CF93-8846-3DC6-FF6529803237}"/>
              </a:ext>
            </a:extLst>
          </p:cNvPr>
          <p:cNvSpPr/>
          <p:nvPr/>
        </p:nvSpPr>
        <p:spPr>
          <a:xfrm>
            <a:off x="8837330" y="5224462"/>
            <a:ext cx="3314700" cy="1153024"/>
          </a:xfrm>
          <a:prstGeom prst="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Fluorescence Image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03870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E8F2D70-99AA-D2F1-CAE5-50D6768BA3A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7C0629EF-27D6-A30F-852A-E7C12AF01E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" y="3429001"/>
            <a:ext cx="3314700" cy="163750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E53CCB8-1388-79B8-A491-9942D4C48483}"/>
              </a:ext>
            </a:extLst>
          </p:cNvPr>
          <p:cNvSpPr txBox="1"/>
          <p:nvPr/>
        </p:nvSpPr>
        <p:spPr>
          <a:xfrm>
            <a:off x="0" y="4710021"/>
            <a:ext cx="1779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3BD9AD7-31B7-022B-29AA-19D66DB796DC}"/>
              </a:ext>
            </a:extLst>
          </p:cNvPr>
          <p:cNvSpPr txBox="1"/>
          <p:nvPr/>
        </p:nvSpPr>
        <p:spPr>
          <a:xfrm>
            <a:off x="5483268" y="1529834"/>
            <a:ext cx="1225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GH5_3-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AE5AC3B-BCF0-7B92-D044-522650D0E8B8}"/>
              </a:ext>
            </a:extLst>
          </p:cNvPr>
          <p:cNvSpPr txBox="1"/>
          <p:nvPr/>
        </p:nvSpPr>
        <p:spPr>
          <a:xfrm>
            <a:off x="4257804" y="1529834"/>
            <a:ext cx="834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for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AD030B-D451-5ECB-48CE-5AE0B15248E7}"/>
              </a:ext>
            </a:extLst>
          </p:cNvPr>
          <p:cNvSpPr txBox="1"/>
          <p:nvPr/>
        </p:nvSpPr>
        <p:spPr>
          <a:xfrm>
            <a:off x="7099993" y="1524000"/>
            <a:ext cx="664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fter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BD66C3AC-7815-54FA-3F12-B0CF8D90B8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179561"/>
            <a:ext cx="3314701" cy="1637501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DE9505A0-677D-8758-3760-4F242ECC16DF}"/>
              </a:ext>
            </a:extLst>
          </p:cNvPr>
          <p:cNvSpPr txBox="1"/>
          <p:nvPr/>
        </p:nvSpPr>
        <p:spPr>
          <a:xfrm>
            <a:off x="50104" y="6435204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  3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4D2F4041-50F5-EA8F-D2CC-CF816AE1747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77299" y="5179560"/>
            <a:ext cx="3314701" cy="1624975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9C5C4D70-D367-A1CA-C993-4C208D1FB3F0}"/>
              </a:ext>
            </a:extLst>
          </p:cNvPr>
          <p:cNvSpPr txBox="1"/>
          <p:nvPr/>
        </p:nvSpPr>
        <p:spPr>
          <a:xfrm>
            <a:off x="8915398" y="4697170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9BC8540-2843-98B3-F450-DEB054419CB7}"/>
              </a:ext>
            </a:extLst>
          </p:cNvPr>
          <p:cNvSpPr txBox="1"/>
          <p:nvPr/>
        </p:nvSpPr>
        <p:spPr>
          <a:xfrm>
            <a:off x="8927402" y="6422353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 3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B77B148E-C727-5CB9-B42D-28C6F5A5851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77299" y="3428999"/>
            <a:ext cx="3314701" cy="1650353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A288DD7-B98C-5F10-DB9C-D29370C1AD75}"/>
              </a:ext>
            </a:extLst>
          </p:cNvPr>
          <p:cNvSpPr txBox="1"/>
          <p:nvPr/>
        </p:nvSpPr>
        <p:spPr>
          <a:xfrm>
            <a:off x="8999984" y="4716445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3</a:t>
            </a:r>
          </a:p>
        </p:txBody>
      </p:sp>
      <p:pic>
        <p:nvPicPr>
          <p:cNvPr id="27" name="Picture 26" descr="A close-up of a blue circle&#10;&#10;Description automatically generated">
            <a:extLst>
              <a:ext uri="{FF2B5EF4-FFF2-40B4-BE49-F238E27FC236}">
                <a16:creationId xmlns:a16="http://schemas.microsoft.com/office/drawing/2014/main" id="{F47A9E47-BB64-962A-8450-D1818314AFF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7958" y="3418976"/>
            <a:ext cx="2369792" cy="3388062"/>
          </a:xfrm>
          <a:prstGeom prst="rect">
            <a:avLst/>
          </a:prstGeom>
        </p:spPr>
      </p:pic>
      <p:pic>
        <p:nvPicPr>
          <p:cNvPr id="29" name="Picture 28" descr="A close-up of a blue circle&#10;&#10;Description automatically generated">
            <a:extLst>
              <a:ext uri="{FF2B5EF4-FFF2-40B4-BE49-F238E27FC236}">
                <a16:creationId xmlns:a16="http://schemas.microsoft.com/office/drawing/2014/main" id="{DCAFCEF8-6F27-7CDE-B4EA-CE976DD263F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4250" y="3429000"/>
            <a:ext cx="2369792" cy="3388061"/>
          </a:xfrm>
          <a:prstGeom prst="rect">
            <a:avLst/>
          </a:prstGeom>
        </p:spPr>
      </p:pic>
      <p:pic>
        <p:nvPicPr>
          <p:cNvPr id="4" name="Picture 3" descr="A group of petri dishes&#10;&#10;Description automatically generated">
            <a:extLst>
              <a:ext uri="{FF2B5EF4-FFF2-40B4-BE49-F238E27FC236}">
                <a16:creationId xmlns:a16="http://schemas.microsoft.com/office/drawing/2014/main" id="{B4F08AA8-F591-CA8E-2846-5770541E735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963" r="49490" b="18889"/>
          <a:stretch/>
        </p:blipFill>
        <p:spPr>
          <a:xfrm>
            <a:off x="1" y="0"/>
            <a:ext cx="3314700" cy="3354153"/>
          </a:xfrm>
          <a:prstGeom prst="rect">
            <a:avLst/>
          </a:prstGeom>
        </p:spPr>
      </p:pic>
      <p:pic>
        <p:nvPicPr>
          <p:cNvPr id="5" name="Picture 4" descr="A group of petri dishes&#10;&#10;Description automatically generated">
            <a:extLst>
              <a:ext uri="{FF2B5EF4-FFF2-40B4-BE49-F238E27FC236}">
                <a16:creationId xmlns:a16="http://schemas.microsoft.com/office/drawing/2014/main" id="{6F75C0E5-3D79-C0A1-2AFD-18F372C9912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295" r="47055" b="18704"/>
          <a:stretch/>
        </p:blipFill>
        <p:spPr>
          <a:xfrm>
            <a:off x="8809426" y="0"/>
            <a:ext cx="3382573" cy="335415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CB340F7-CAAF-BB5A-3210-0ECA1A694792}"/>
              </a:ext>
            </a:extLst>
          </p:cNvPr>
          <p:cNvSpPr txBox="1"/>
          <p:nvPr/>
        </p:nvSpPr>
        <p:spPr>
          <a:xfrm>
            <a:off x="5220251" y="4643169"/>
            <a:ext cx="354584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3 </a:t>
            </a: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r>
              <a:rPr lang="en-US" b="1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40150E4-8C4B-688E-E121-7BAD575B4B50}"/>
              </a:ext>
            </a:extLst>
          </p:cNvPr>
          <p:cNvSpPr txBox="1"/>
          <p:nvPr/>
        </p:nvSpPr>
        <p:spPr>
          <a:xfrm>
            <a:off x="7953926" y="4643169"/>
            <a:ext cx="354584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3 </a:t>
            </a: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r>
              <a:rPr lang="en-US" b="1" dirty="0">
                <a:solidFill>
                  <a:schemeClr val="bg1"/>
                </a:solidFill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28263799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E02A626-8005-C166-83E7-D07BC61EAC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429000"/>
            <a:ext cx="3324225" cy="176212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2AE7757-89BA-0E96-AB54-858A3D5F892A}"/>
              </a:ext>
            </a:extLst>
          </p:cNvPr>
          <p:cNvSpPr txBox="1"/>
          <p:nvPr/>
        </p:nvSpPr>
        <p:spPr>
          <a:xfrm>
            <a:off x="19050" y="4810229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7                                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305028-F2A3-490B-FD48-CC00CFAAF63F}"/>
              </a:ext>
            </a:extLst>
          </p:cNvPr>
          <p:cNvSpPr txBox="1"/>
          <p:nvPr/>
        </p:nvSpPr>
        <p:spPr>
          <a:xfrm>
            <a:off x="5487596" y="1524000"/>
            <a:ext cx="12168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GH5_6-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32B3C80-678F-EDCB-BB29-2E881AE90543}"/>
              </a:ext>
            </a:extLst>
          </p:cNvPr>
          <p:cNvSpPr txBox="1"/>
          <p:nvPr/>
        </p:nvSpPr>
        <p:spPr>
          <a:xfrm>
            <a:off x="4257804" y="1524000"/>
            <a:ext cx="834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for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547BF16-6188-6BE7-8642-8D4A027825F5}"/>
              </a:ext>
            </a:extLst>
          </p:cNvPr>
          <p:cNvSpPr txBox="1"/>
          <p:nvPr/>
        </p:nvSpPr>
        <p:spPr>
          <a:xfrm>
            <a:off x="7099993" y="1524000"/>
            <a:ext cx="664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fter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2CB7CD73-A41B-1FCD-8059-A310E62B9F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" y="5279986"/>
            <a:ext cx="3324224" cy="152929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6076F38-D6C6-B75F-23C1-A7B80CE50F99}"/>
              </a:ext>
            </a:extLst>
          </p:cNvPr>
          <p:cNvSpPr txBox="1"/>
          <p:nvPr/>
        </p:nvSpPr>
        <p:spPr>
          <a:xfrm>
            <a:off x="19050" y="6439948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7                                6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05B5C72F-0DA4-5A8A-AAA2-79196024CE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77298" y="5279986"/>
            <a:ext cx="3314702" cy="1529294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68966C2-70B8-7586-20B2-F4A1219CD688}"/>
              </a:ext>
            </a:extLst>
          </p:cNvPr>
          <p:cNvSpPr txBox="1"/>
          <p:nvPr/>
        </p:nvSpPr>
        <p:spPr>
          <a:xfrm>
            <a:off x="8943973" y="6439948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7                              6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3601E969-CA5E-92FA-5403-AFAF085C9B3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77298" y="3428999"/>
            <a:ext cx="3314702" cy="176212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5D331E2-E6E9-1557-F18B-02B840ADBFCD}"/>
              </a:ext>
            </a:extLst>
          </p:cNvPr>
          <p:cNvSpPr txBox="1"/>
          <p:nvPr/>
        </p:nvSpPr>
        <p:spPr>
          <a:xfrm>
            <a:off x="8982073" y="4810229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7                                6</a:t>
            </a:r>
          </a:p>
        </p:txBody>
      </p:sp>
      <p:pic>
        <p:nvPicPr>
          <p:cNvPr id="19" name="Picture 18" descr="A close-up of a blue circle&#10;&#10;Description automatically generated">
            <a:extLst>
              <a:ext uri="{FF2B5EF4-FFF2-40B4-BE49-F238E27FC236}">
                <a16:creationId xmlns:a16="http://schemas.microsoft.com/office/drawing/2014/main" id="{21C81086-033D-8CE7-B91E-7D5520DAD27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9063" y="3429000"/>
            <a:ext cx="2364349" cy="3380281"/>
          </a:xfrm>
          <a:prstGeom prst="rect">
            <a:avLst/>
          </a:prstGeom>
        </p:spPr>
      </p:pic>
      <p:pic>
        <p:nvPicPr>
          <p:cNvPr id="22" name="Picture 21" descr="A close-up of a pair of circles&#10;&#10;Description automatically generated">
            <a:extLst>
              <a:ext uri="{FF2B5EF4-FFF2-40B4-BE49-F238E27FC236}">
                <a16:creationId xmlns:a16="http://schemas.microsoft.com/office/drawing/2014/main" id="{923B0FC9-82A5-4231-8752-50B364C75E2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8111" y="3429000"/>
            <a:ext cx="2364349" cy="3380280"/>
          </a:xfrm>
          <a:prstGeom prst="rect">
            <a:avLst/>
          </a:prstGeom>
        </p:spPr>
      </p:pic>
      <p:pic>
        <p:nvPicPr>
          <p:cNvPr id="9" name="Picture 8" descr="A group of petri dishes&#10;&#10;Description automatically generated">
            <a:extLst>
              <a:ext uri="{FF2B5EF4-FFF2-40B4-BE49-F238E27FC236}">
                <a16:creationId xmlns:a16="http://schemas.microsoft.com/office/drawing/2014/main" id="{086B7212-C938-9F69-1AF5-39B46319595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27" t="12963" b="18889"/>
          <a:stretch/>
        </p:blipFill>
        <p:spPr>
          <a:xfrm>
            <a:off x="-1" y="-1"/>
            <a:ext cx="3324224" cy="3366245"/>
          </a:xfrm>
          <a:prstGeom prst="rect">
            <a:avLst/>
          </a:prstGeom>
        </p:spPr>
      </p:pic>
      <p:pic>
        <p:nvPicPr>
          <p:cNvPr id="11" name="Picture 10" descr="A group of petri dishes&#10;&#10;Description automatically generated">
            <a:extLst>
              <a:ext uri="{FF2B5EF4-FFF2-40B4-BE49-F238E27FC236}">
                <a16:creationId xmlns:a16="http://schemas.microsoft.com/office/drawing/2014/main" id="{557DD997-D7A6-1035-E917-B58E001F9AA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28" t="11295" b="18704"/>
          <a:stretch/>
        </p:blipFill>
        <p:spPr>
          <a:xfrm>
            <a:off x="9105900" y="0"/>
            <a:ext cx="3095624" cy="3352853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CE87685-4F94-2CC3-62BE-34A9B2C54EBA}"/>
              </a:ext>
            </a:extLst>
          </p:cNvPr>
          <p:cNvSpPr txBox="1"/>
          <p:nvPr/>
        </p:nvSpPr>
        <p:spPr>
          <a:xfrm>
            <a:off x="5220251" y="4643169"/>
            <a:ext cx="354584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6 </a:t>
            </a: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r>
              <a:rPr lang="en-US" b="1" dirty="0">
                <a:solidFill>
                  <a:schemeClr val="bg1"/>
                </a:solidFill>
              </a:rPr>
              <a:t>7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AF8FB00-3F57-5888-221A-2EF94479DCA1}"/>
              </a:ext>
            </a:extLst>
          </p:cNvPr>
          <p:cNvSpPr txBox="1"/>
          <p:nvPr/>
        </p:nvSpPr>
        <p:spPr>
          <a:xfrm>
            <a:off x="8020601" y="4685622"/>
            <a:ext cx="354584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6 </a:t>
            </a: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r>
              <a:rPr lang="en-US" b="1" dirty="0">
                <a:solidFill>
                  <a:schemeClr val="bg1"/>
                </a:solidFill>
              </a:rPr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32089049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095EBB1-DC90-291D-E7C8-6AA6B8FEAB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429000"/>
            <a:ext cx="3356975" cy="171919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72E59BE-DCED-BE37-829E-5FD4271E5068}"/>
              </a:ext>
            </a:extLst>
          </p:cNvPr>
          <p:cNvSpPr txBox="1"/>
          <p:nvPr/>
        </p:nvSpPr>
        <p:spPr>
          <a:xfrm>
            <a:off x="5421552" y="1525902"/>
            <a:ext cx="1348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GH53_1-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24E758A-7E16-44EE-C055-9BF35B5EF0DE}"/>
              </a:ext>
            </a:extLst>
          </p:cNvPr>
          <p:cNvSpPr txBox="1"/>
          <p:nvPr/>
        </p:nvSpPr>
        <p:spPr>
          <a:xfrm>
            <a:off x="4257804" y="1524000"/>
            <a:ext cx="834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for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5FF536-41A5-8547-A306-265AD0C8C564}"/>
              </a:ext>
            </a:extLst>
          </p:cNvPr>
          <p:cNvSpPr txBox="1"/>
          <p:nvPr/>
        </p:nvSpPr>
        <p:spPr>
          <a:xfrm>
            <a:off x="7099993" y="1524000"/>
            <a:ext cx="664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fte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21337B0-AE3D-DC6D-94C1-A7D0AED31117}"/>
              </a:ext>
            </a:extLst>
          </p:cNvPr>
          <p:cNvSpPr txBox="1"/>
          <p:nvPr/>
        </p:nvSpPr>
        <p:spPr>
          <a:xfrm>
            <a:off x="19050" y="4810229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2                                1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C70A1ED-1287-3D76-1DC2-869DFA24171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1" y="5246236"/>
            <a:ext cx="3356975" cy="153556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04C891A-EB35-04C9-179D-F1C65EA924C9}"/>
              </a:ext>
            </a:extLst>
          </p:cNvPr>
          <p:cNvSpPr txBox="1"/>
          <p:nvPr/>
        </p:nvSpPr>
        <p:spPr>
          <a:xfrm>
            <a:off x="-1" y="6412467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2                                1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4FCCD1A-8444-6DE9-A3E2-2EBD464C24B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69897" y="5246235"/>
            <a:ext cx="3322103" cy="1535563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8320BA9E-3327-111D-90A6-080AE0EF5B60}"/>
              </a:ext>
            </a:extLst>
          </p:cNvPr>
          <p:cNvSpPr txBox="1"/>
          <p:nvPr/>
        </p:nvSpPr>
        <p:spPr>
          <a:xfrm>
            <a:off x="8963024" y="6412467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2                                1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F60443F-0837-821E-AD25-2577776C6CD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69896" y="3428999"/>
            <a:ext cx="3322104" cy="1719197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71D61EB8-3001-A06B-6A23-A107ED49E53E}"/>
              </a:ext>
            </a:extLst>
          </p:cNvPr>
          <p:cNvSpPr txBox="1"/>
          <p:nvPr/>
        </p:nvSpPr>
        <p:spPr>
          <a:xfrm>
            <a:off x="8907996" y="4827884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2                               1</a:t>
            </a:r>
          </a:p>
        </p:txBody>
      </p:sp>
      <p:pic>
        <p:nvPicPr>
          <p:cNvPr id="18" name="Picture 17" descr="A close-up of a blue circle&#10;&#10;Description automatically generated">
            <a:extLst>
              <a:ext uri="{FF2B5EF4-FFF2-40B4-BE49-F238E27FC236}">
                <a16:creationId xmlns:a16="http://schemas.microsoft.com/office/drawing/2014/main" id="{10402299-9A49-AACB-918A-E95ACF607FB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7585" y="3429000"/>
            <a:ext cx="2345127" cy="3352799"/>
          </a:xfrm>
          <a:prstGeom prst="rect">
            <a:avLst/>
          </a:prstGeom>
        </p:spPr>
      </p:pic>
      <p:pic>
        <p:nvPicPr>
          <p:cNvPr id="20" name="Picture 19" descr="A close-up of a blue circle&#10;&#10;Description automatically generated">
            <a:extLst>
              <a:ext uri="{FF2B5EF4-FFF2-40B4-BE49-F238E27FC236}">
                <a16:creationId xmlns:a16="http://schemas.microsoft.com/office/drawing/2014/main" id="{4E920246-667B-2D47-E7BA-7E6C81E4452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4158" y="3428999"/>
            <a:ext cx="2345126" cy="3352798"/>
          </a:xfrm>
          <a:prstGeom prst="rect">
            <a:avLst/>
          </a:prstGeom>
        </p:spPr>
      </p:pic>
      <p:pic>
        <p:nvPicPr>
          <p:cNvPr id="8" name="Picture 7" descr="A group of petri dishes with white mold&#10;&#10;Description automatically generated">
            <a:extLst>
              <a:ext uri="{FF2B5EF4-FFF2-40B4-BE49-F238E27FC236}">
                <a16:creationId xmlns:a16="http://schemas.microsoft.com/office/drawing/2014/main" id="{D2A148A0-E65E-C0C8-F12E-C61FE59BD90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622" r="49584" b="15965"/>
          <a:stretch/>
        </p:blipFill>
        <p:spPr>
          <a:xfrm>
            <a:off x="-1" y="0"/>
            <a:ext cx="3356975" cy="3416395"/>
          </a:xfrm>
          <a:prstGeom prst="rect">
            <a:avLst/>
          </a:prstGeom>
        </p:spPr>
      </p:pic>
      <p:pic>
        <p:nvPicPr>
          <p:cNvPr id="11" name="Picture 10" descr="Several round petri dishes with brown mold&#10;&#10;Description automatically generated with medium confidence">
            <a:extLst>
              <a:ext uri="{FF2B5EF4-FFF2-40B4-BE49-F238E27FC236}">
                <a16:creationId xmlns:a16="http://schemas.microsoft.com/office/drawing/2014/main" id="{BA3CAD10-3678-86EE-8DBD-ECC34391DA5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520" r="50000" b="15965"/>
          <a:stretch/>
        </p:blipFill>
        <p:spPr>
          <a:xfrm>
            <a:off x="8752653" y="0"/>
            <a:ext cx="3439347" cy="337997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244BB5E2-94CA-B675-C4AD-49CBC3C7B4C9}"/>
              </a:ext>
            </a:extLst>
          </p:cNvPr>
          <p:cNvSpPr txBox="1"/>
          <p:nvPr/>
        </p:nvSpPr>
        <p:spPr>
          <a:xfrm>
            <a:off x="7906301" y="4705766"/>
            <a:ext cx="354584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1 </a:t>
            </a: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r>
              <a:rPr lang="en-US" b="1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D0CB17E-2E19-B508-51A7-83F3DB14203D}"/>
              </a:ext>
            </a:extLst>
          </p:cNvPr>
          <p:cNvSpPr txBox="1"/>
          <p:nvPr/>
        </p:nvSpPr>
        <p:spPr>
          <a:xfrm>
            <a:off x="5206160" y="4744282"/>
            <a:ext cx="354584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1 </a:t>
            </a: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r>
              <a:rPr lang="en-US" b="1" dirty="0">
                <a:solidFill>
                  <a:schemeClr val="bg1"/>
                </a:solidFill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15634751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A749EEA-6C90-8661-40EA-AB4AF62DF28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4425"/>
          <a:stretch/>
        </p:blipFill>
        <p:spPr>
          <a:xfrm>
            <a:off x="0" y="3429000"/>
            <a:ext cx="3356975" cy="175677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CDC387D-BA08-2858-5698-59C56335C2AE}"/>
              </a:ext>
            </a:extLst>
          </p:cNvPr>
          <p:cNvSpPr txBox="1"/>
          <p:nvPr/>
        </p:nvSpPr>
        <p:spPr>
          <a:xfrm>
            <a:off x="19050" y="4810229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  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5ED2ED6-5CE6-4756-5868-3D046415983F}"/>
              </a:ext>
            </a:extLst>
          </p:cNvPr>
          <p:cNvSpPr txBox="1"/>
          <p:nvPr/>
        </p:nvSpPr>
        <p:spPr>
          <a:xfrm>
            <a:off x="5421552" y="1524000"/>
            <a:ext cx="1348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GH53_4-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C1BB0F0-D011-32D0-1A86-401BE521A372}"/>
              </a:ext>
            </a:extLst>
          </p:cNvPr>
          <p:cNvSpPr txBox="1"/>
          <p:nvPr/>
        </p:nvSpPr>
        <p:spPr>
          <a:xfrm>
            <a:off x="4257804" y="1524000"/>
            <a:ext cx="834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for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B7E582D-05E8-948C-3DEE-3AA3402976F6}"/>
              </a:ext>
            </a:extLst>
          </p:cNvPr>
          <p:cNvSpPr txBox="1"/>
          <p:nvPr/>
        </p:nvSpPr>
        <p:spPr>
          <a:xfrm>
            <a:off x="7099993" y="1524000"/>
            <a:ext cx="664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fter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30FBDD08-EB98-25C3-427F-A208FBB416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257799"/>
            <a:ext cx="3356975" cy="151447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7974C2B-70D3-86A9-F657-13602532A545}"/>
              </a:ext>
            </a:extLst>
          </p:cNvPr>
          <p:cNvSpPr txBox="1"/>
          <p:nvPr/>
        </p:nvSpPr>
        <p:spPr>
          <a:xfrm>
            <a:off x="19049" y="6402943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  4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85934B25-C554-D904-873C-794369258B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35027" y="5257799"/>
            <a:ext cx="3337923" cy="151447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163486B-001A-5F01-93E2-AF73C38B8027}"/>
              </a:ext>
            </a:extLst>
          </p:cNvPr>
          <p:cNvSpPr txBox="1"/>
          <p:nvPr/>
        </p:nvSpPr>
        <p:spPr>
          <a:xfrm>
            <a:off x="8943974" y="6402943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  4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D542B4F-F7A4-5739-6C40-CA1F40BD195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35025" y="3429000"/>
            <a:ext cx="3356975" cy="1750561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8F580715-115D-5A15-25CB-456FB975AF47}"/>
              </a:ext>
            </a:extLst>
          </p:cNvPr>
          <p:cNvSpPr txBox="1"/>
          <p:nvPr/>
        </p:nvSpPr>
        <p:spPr>
          <a:xfrm>
            <a:off x="8934448" y="4810229"/>
            <a:ext cx="191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                                4</a:t>
            </a:r>
          </a:p>
        </p:txBody>
      </p:sp>
      <p:pic>
        <p:nvPicPr>
          <p:cNvPr id="18" name="Picture 17" descr="A close-up of blue circles&#10;&#10;Description automatically generated">
            <a:extLst>
              <a:ext uri="{FF2B5EF4-FFF2-40B4-BE49-F238E27FC236}">
                <a16:creationId xmlns:a16="http://schemas.microsoft.com/office/drawing/2014/main" id="{4EA243DF-888A-132C-3C6A-0DC619B8609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7355" y="3429000"/>
            <a:ext cx="2338466" cy="3343276"/>
          </a:xfrm>
          <a:prstGeom prst="rect">
            <a:avLst/>
          </a:prstGeom>
        </p:spPr>
      </p:pic>
      <p:pic>
        <p:nvPicPr>
          <p:cNvPr id="20" name="Picture 19" descr="A close-up of a blue circle&#10;&#10;Description automatically generated">
            <a:extLst>
              <a:ext uri="{FF2B5EF4-FFF2-40B4-BE49-F238E27FC236}">
                <a16:creationId xmlns:a16="http://schemas.microsoft.com/office/drawing/2014/main" id="{B86D9A2F-2FF3-C940-7A1D-08A75E64812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6520" y="3428999"/>
            <a:ext cx="2338466" cy="3343276"/>
          </a:xfrm>
          <a:prstGeom prst="rect">
            <a:avLst/>
          </a:prstGeom>
        </p:spPr>
      </p:pic>
      <p:pic>
        <p:nvPicPr>
          <p:cNvPr id="2" name="Picture 1" descr="A group of petri dishes with white mold&#10;&#10;Description automatically generated">
            <a:extLst>
              <a:ext uri="{FF2B5EF4-FFF2-40B4-BE49-F238E27FC236}">
                <a16:creationId xmlns:a16="http://schemas.microsoft.com/office/drawing/2014/main" id="{39F3EB71-EB13-AB70-784E-6A97DAAE9AE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15622" b="15965"/>
          <a:stretch/>
        </p:blipFill>
        <p:spPr>
          <a:xfrm>
            <a:off x="0" y="0"/>
            <a:ext cx="3356975" cy="3444867"/>
          </a:xfrm>
          <a:prstGeom prst="rect">
            <a:avLst/>
          </a:prstGeom>
        </p:spPr>
      </p:pic>
      <p:pic>
        <p:nvPicPr>
          <p:cNvPr id="11" name="Picture 10" descr="Several round petri dishes with brown mold&#10;&#10;Description automatically generated with medium confidence">
            <a:extLst>
              <a:ext uri="{FF2B5EF4-FFF2-40B4-BE49-F238E27FC236}">
                <a16:creationId xmlns:a16="http://schemas.microsoft.com/office/drawing/2014/main" id="{96465E67-01D7-2656-A244-6449B7EEC6F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50" t="18520" b="15965"/>
          <a:stretch/>
        </p:blipFill>
        <p:spPr>
          <a:xfrm>
            <a:off x="8835024" y="0"/>
            <a:ext cx="3356976" cy="3369811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E9951808-C0F8-BE2E-DD94-6E4C13CFAB50}"/>
              </a:ext>
            </a:extLst>
          </p:cNvPr>
          <p:cNvSpPr txBox="1"/>
          <p:nvPr/>
        </p:nvSpPr>
        <p:spPr>
          <a:xfrm>
            <a:off x="5244260" y="4513106"/>
            <a:ext cx="354584" cy="1969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4 </a:t>
            </a: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sz="1400" b="1" dirty="0">
              <a:solidFill>
                <a:schemeClr val="bg1"/>
              </a:solidFill>
            </a:endParaRPr>
          </a:p>
          <a:p>
            <a:r>
              <a:rPr lang="en-US" b="1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138307C-EE9F-3675-0C8E-083DF9AF5527}"/>
              </a:ext>
            </a:extLst>
          </p:cNvPr>
          <p:cNvSpPr txBox="1"/>
          <p:nvPr/>
        </p:nvSpPr>
        <p:spPr>
          <a:xfrm>
            <a:off x="7959032" y="4513106"/>
            <a:ext cx="354584" cy="1969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4 </a:t>
            </a: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b="1" dirty="0">
              <a:solidFill>
                <a:schemeClr val="bg1"/>
              </a:solidFill>
            </a:endParaRPr>
          </a:p>
          <a:p>
            <a:endParaRPr lang="en-US" sz="1400" b="1" dirty="0">
              <a:solidFill>
                <a:schemeClr val="bg1"/>
              </a:solidFill>
            </a:endParaRPr>
          </a:p>
          <a:p>
            <a:r>
              <a:rPr lang="en-US" b="1" dirty="0">
                <a:solidFill>
                  <a:schemeClr val="bg1"/>
                </a:solidFill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3040872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116</Words>
  <Application>Microsoft Office PowerPoint</Application>
  <PresentationFormat>Widescreen</PresentationFormat>
  <Paragraphs>116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aek, Insuck - REE-ARS</dc:creator>
  <cp:lastModifiedBy>Ezekiel Ahn</cp:lastModifiedBy>
  <cp:revision>11</cp:revision>
  <dcterms:created xsi:type="dcterms:W3CDTF">2025-04-11T19:49:13Z</dcterms:created>
  <dcterms:modified xsi:type="dcterms:W3CDTF">2025-04-14T22:01:13Z</dcterms:modified>
</cp:coreProperties>
</file>